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91" r:id="rId2"/>
    <p:sldId id="290" r:id="rId3"/>
  </p:sldIdLst>
  <p:sldSz cx="7559675" cy="1069181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413" userDrawn="1">
          <p15:clr>
            <a:srgbClr val="A4A3A4"/>
          </p15:clr>
        </p15:guide>
        <p15:guide id="2" pos="222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977" autoAdjust="0"/>
    <p:restoredTop sz="94660"/>
  </p:normalViewPr>
  <p:slideViewPr>
    <p:cSldViewPr snapToGrid="0">
      <p:cViewPr>
        <p:scale>
          <a:sx n="100" d="100"/>
          <a:sy n="100" d="100"/>
        </p:scale>
        <p:origin x="-1872" y="2106"/>
      </p:cViewPr>
      <p:guideLst>
        <p:guide orient="horz" pos="3413"/>
        <p:guide pos="22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420CF5-109E-4605-9232-27F0EC347CA6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0DC6E8-F2D3-47BC-9F6E-0B653624ECE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58011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856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5376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9540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3982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3061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1816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240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2978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8738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5672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8235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1034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1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1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직사각형 9"/>
          <p:cNvSpPr/>
          <p:nvPr/>
        </p:nvSpPr>
        <p:spPr>
          <a:xfrm>
            <a:off x="1331595" y="6115338"/>
            <a:ext cx="4700905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 </a:t>
            </a:r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Table S3. </a:t>
            </a:r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Classification of up- and down-regulated genes in </a:t>
            </a:r>
            <a:r>
              <a:rPr lang="en-US" altLang="ko-KR" sz="1400" i="1" dirty="0" smtClean="0">
                <a:latin typeface="Arial" pitchFamily="34" charset="0"/>
                <a:cs typeface="Arial" pitchFamily="34" charset="0"/>
              </a:rPr>
              <a:t>OsVIL2</a:t>
            </a:r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 -OX. </a:t>
            </a:r>
            <a:r>
              <a:rPr lang="en-US" altLang="ko-KR" sz="14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he functional groups that are significantly abundant in the increased genes are indicated in blue.</a:t>
            </a:r>
            <a:endParaRPr lang="ko-KR" altLang="en-US" sz="14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9771291"/>
              </p:ext>
            </p:extLst>
          </p:nvPr>
        </p:nvGraphicFramePr>
        <p:xfrm>
          <a:off x="1409795" y="1583055"/>
          <a:ext cx="3990880" cy="44005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52605"/>
                <a:gridCol w="561975"/>
                <a:gridCol w="876300"/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Func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up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ow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iotic/abiotic stres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5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8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ell </a:t>
                      </a:r>
                      <a:r>
                        <a:rPr lang="en-US" sz="1200" u="none" strike="noStrike" dirty="0" smtClean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ivision/cell </a:t>
                      </a:r>
                      <a:r>
                        <a:rPr lang="en-US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ycle</a:t>
                      </a:r>
                      <a:endParaRPr lang="en-US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1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ell </a:t>
                      </a:r>
                      <a:r>
                        <a:rPr lang="en-US" sz="1200" u="none" strike="noStrike" dirty="0" smtClean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organization</a:t>
                      </a:r>
                      <a:endParaRPr lang="en-US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1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9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evelopmen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4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6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NA repai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NA synthesis</a:t>
                      </a:r>
                      <a:endParaRPr lang="en-US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6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Enzyme familie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28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4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ormone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4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l handlin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rotein degradatio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8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rotein modificatio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9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rotein synthesis/AA </a:t>
                      </a:r>
                      <a:r>
                        <a:rPr lang="en-US" sz="1200" u="none" strike="noStrike" dirty="0" smtClean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ctivation</a:t>
                      </a:r>
                      <a:endParaRPr lang="en-US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6</a:t>
                      </a:r>
                      <a:endParaRPr lang="en-US" altLang="ko-KR" sz="1200" b="0" i="0" u="none" strike="noStrike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solidFill>
                            <a:srgbClr val="00B0F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edox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egul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9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5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egulation of transcrip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7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9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NA process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RNA synthe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ranspo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6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9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Unclassified/unknow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71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84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Vesicle transport/protein target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cxnSp>
        <p:nvCxnSpPr>
          <p:cNvPr id="11" name="직선 연결선 10"/>
          <p:cNvCxnSpPr/>
          <p:nvPr/>
        </p:nvCxnSpPr>
        <p:spPr>
          <a:xfrm>
            <a:off x="1283970" y="1578792"/>
            <a:ext cx="43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1283970" y="1789430"/>
            <a:ext cx="43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1283970" y="5993130"/>
            <a:ext cx="43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776120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/>
          <p:cNvSpPr/>
          <p:nvPr/>
        </p:nvSpPr>
        <p:spPr>
          <a:xfrm>
            <a:off x="785181" y="9220607"/>
            <a:ext cx="493485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 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Table S6. 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Primers </a:t>
            </a:r>
            <a:r>
              <a:rPr lang="en-US" altLang="ko-KR" sz="1600" dirty="0">
                <a:latin typeface="Arial" pitchFamily="34" charset="0"/>
                <a:cs typeface="Arial" pitchFamily="34" charset="0"/>
              </a:rPr>
              <a:t>used 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in this study.</a:t>
            </a:r>
            <a:endParaRPr lang="ko-KR" altLang="en-US" sz="16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5440555"/>
              </p:ext>
            </p:extLst>
          </p:nvPr>
        </p:nvGraphicFramePr>
        <p:xfrm>
          <a:off x="1015062" y="96248"/>
          <a:ext cx="5485096" cy="895720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9042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912534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82133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am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Sequence (5'-3'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urpos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Ubi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CCAGCTGAGGCCCAAG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qRT-PC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Ubi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CGATTGATTTAACCAGTGGATG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GTCCCTTCTACAATGGTG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TCCTGACCTGCTCTTGC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12g03040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GGCACATCAGCTAACAAC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12g03040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GCAGGAGGTTGTTGAGAG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03g02550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GAGAGAGGAGCGTGAT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03g02550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CTGACGTTGAGAGCTGG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06g19444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GAGGCAAGCTAGGTCCAG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EP1-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GATCAGGGAAAGGAGAC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EP1-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AAATGCTGGGCAGAGTAG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ST-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CTACTGCTGGCGTTG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ST-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AGATGGTGCTGGTGCG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TGAAGAGATGATGTCATT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GCATCATCCCTCCCTCTA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06g19444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TCCCGAAAGCAACAGAA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01g15900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CTGCACCACCATTTCCAT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01g15900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CCTTTGCAACTCCTATC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02g58160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TGAAAGCATTTCGGACC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9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02g58160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CTTTGCACGACGACTCC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0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11g15040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GATCGAGCGAGATTTCC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1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OC_Os11g15040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GGAGGAATGGAAGAGAT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2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VIL2_full_HindIII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sng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GCTT</a:t>
                      </a:r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ATTCGCCATG GATCCAC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ransgenic plan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3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VIL2_full_SpeI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sng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CTAGT</a:t>
                      </a:r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TGCCAAAGT TCCATGC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4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OsCKX2-1F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CCTTGTCCCTTCTACAA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I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5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1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ACGAAGCAGTTGAGCATG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6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2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CTCCCTTGTGGAGTAC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7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2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CTGTGTGACAAGGACTG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8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3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GGTGAACTAATTGGCTG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9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3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GCCGGTAACACATTTGAA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0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4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GGTGAACTAATTGGCTG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1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4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ACCACACATCCAAAAATA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2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5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GACTCGAGCAAGGTACC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3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5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CACATCCTTTTTGAGAC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4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6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ATATGGGGACGTCGTGAC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5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6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TTCTCGTTCACCCTGAAGT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6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7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AAAGATCCGTGCATTTC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7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7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CCTAGATGGACCGAGGA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8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8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TGATGGCGGGAACAACT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9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8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TTAATTGCATGCGTGCGT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0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9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TGGCTGAACCTGTTCC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1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CKX2-9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TGAGGGGTCGTCATTTTG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2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1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GTTGCGACTTTCATTATATG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3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1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GACTAAGTCGAGACTTCTAACG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4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2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CCTTTCTACTCGTTAGAAGTCTC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5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2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TTCAACATATTACTGTATTGGAA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6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3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GAGCATAAGAAGCTGAAAAGA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7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3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AGGGAGCTGAGAGGGAA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8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4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TGGTTCTTTCTTCCCTCC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9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4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CTTGGCGGGTTCACTAAT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50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5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ACTGTGCTGTTCGCTGGA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51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5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AAAGATCATCAGGGAGAAC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52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6F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ATTTGGCGAGTTCGATGA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53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sLP-6R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GCAGAGGAAACCTCTTCG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54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ctin-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TGACAGGATGAGCAAGG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55"/>
                  </a:ext>
                </a:extLst>
              </a:tr>
              <a:tr h="130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Actin-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GGCAATCCACATCTGCTG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맑은 고딕" panose="020B0503020000020004" pitchFamily="50" charset="-127"/>
                        <a:cs typeface="Arial" pitchFamily="34" charset="0"/>
                      </a:endParaRPr>
                    </a:p>
                  </a:txBody>
                  <a:tcPr marL="4744" marR="4744" marT="4744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56"/>
                  </a:ext>
                </a:extLst>
              </a:tr>
            </a:tbl>
          </a:graphicData>
        </a:graphic>
      </p:graphicFrame>
      <p:cxnSp>
        <p:nvCxnSpPr>
          <p:cNvPr id="4" name="직선 연결선 3"/>
          <p:cNvCxnSpPr/>
          <p:nvPr/>
        </p:nvCxnSpPr>
        <p:spPr>
          <a:xfrm>
            <a:off x="883920" y="3718560"/>
            <a:ext cx="56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연결선 16"/>
          <p:cNvCxnSpPr/>
          <p:nvPr/>
        </p:nvCxnSpPr>
        <p:spPr>
          <a:xfrm>
            <a:off x="883920" y="4023360"/>
            <a:ext cx="56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/>
          <p:cNvCxnSpPr/>
          <p:nvPr/>
        </p:nvCxnSpPr>
        <p:spPr>
          <a:xfrm>
            <a:off x="883920" y="83820"/>
            <a:ext cx="56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883920" y="259080"/>
            <a:ext cx="56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883920" y="9052213"/>
            <a:ext cx="56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62976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10</TotalTime>
  <Words>207</Words>
  <Application>Microsoft Office PowerPoint</Application>
  <PresentationFormat>사용자 지정</PresentationFormat>
  <Paragraphs>185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정일</dc:creator>
  <cp:lastModifiedBy>User</cp:lastModifiedBy>
  <cp:revision>555</cp:revision>
  <dcterms:created xsi:type="dcterms:W3CDTF">2014-12-16T14:08:06Z</dcterms:created>
  <dcterms:modified xsi:type="dcterms:W3CDTF">2018-05-17T14:37:24Z</dcterms:modified>
</cp:coreProperties>
</file>